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notesMasterIdLst>
    <p:notesMasterId r:id="rId3"/>
  </p:notesMasterIdLst>
  <p:sldIdLst>
    <p:sldId id="256" r:id="rId2"/>
  </p:sldIdLst>
  <p:sldSz cx="6858000" cy="9144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122" d="100"/>
          <a:sy n="122" d="100"/>
        </p:scale>
        <p:origin x="3936" y="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0756D4E-E2F4-45B1-99DA-86695A24BBD9}" type="datetimeFigureOut">
              <a:rPr kumimoji="1" lang="ja-JP" altLang="en-US" smtClean="0"/>
              <a:t>2021/6/14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2271713" y="1143000"/>
            <a:ext cx="23145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6514C8E7-9F3F-4D49-B98B-100D9EA2C2B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4982397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70D732-52B1-42CB-AD8C-2DC684696488}" type="datetimeFigureOut">
              <a:rPr kumimoji="1" lang="ja-JP" altLang="en-US" smtClean="0"/>
              <a:t>2021/6/1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2279A8-DCD9-4E32-ABFF-46F947C2A06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5189403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70D732-52B1-42CB-AD8C-2DC684696488}" type="datetimeFigureOut">
              <a:rPr kumimoji="1" lang="ja-JP" altLang="en-US" smtClean="0"/>
              <a:t>2021/6/1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2279A8-DCD9-4E32-ABFF-46F947C2A06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0022217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70D732-52B1-42CB-AD8C-2DC684696488}" type="datetimeFigureOut">
              <a:rPr kumimoji="1" lang="ja-JP" altLang="en-US" smtClean="0"/>
              <a:t>2021/6/1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2279A8-DCD9-4E32-ABFF-46F947C2A06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1662242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70D732-52B1-42CB-AD8C-2DC684696488}" type="datetimeFigureOut">
              <a:rPr kumimoji="1" lang="ja-JP" altLang="en-US" smtClean="0"/>
              <a:t>2021/6/1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2279A8-DCD9-4E32-ABFF-46F947C2A06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0993860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70D732-52B1-42CB-AD8C-2DC684696488}" type="datetimeFigureOut">
              <a:rPr kumimoji="1" lang="ja-JP" altLang="en-US" smtClean="0"/>
              <a:t>2021/6/1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2279A8-DCD9-4E32-ABFF-46F947C2A06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1386939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70D732-52B1-42CB-AD8C-2DC684696488}" type="datetimeFigureOut">
              <a:rPr kumimoji="1" lang="ja-JP" altLang="en-US" smtClean="0"/>
              <a:t>2021/6/14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2279A8-DCD9-4E32-ABFF-46F947C2A06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8307432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70D732-52B1-42CB-AD8C-2DC684696488}" type="datetimeFigureOut">
              <a:rPr kumimoji="1" lang="ja-JP" altLang="en-US" smtClean="0"/>
              <a:t>2021/6/14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2279A8-DCD9-4E32-ABFF-46F947C2A06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7918427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70D732-52B1-42CB-AD8C-2DC684696488}" type="datetimeFigureOut">
              <a:rPr kumimoji="1" lang="ja-JP" altLang="en-US" smtClean="0"/>
              <a:t>2021/6/14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2279A8-DCD9-4E32-ABFF-46F947C2A06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8802270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70D732-52B1-42CB-AD8C-2DC684696488}" type="datetimeFigureOut">
              <a:rPr kumimoji="1" lang="ja-JP" altLang="en-US" smtClean="0"/>
              <a:t>2021/6/14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2279A8-DCD9-4E32-ABFF-46F947C2A06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0006868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70D732-52B1-42CB-AD8C-2DC684696488}" type="datetimeFigureOut">
              <a:rPr kumimoji="1" lang="ja-JP" altLang="en-US" smtClean="0"/>
              <a:t>2021/6/14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2279A8-DCD9-4E32-ABFF-46F947C2A06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038795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70D732-52B1-42CB-AD8C-2DC684696488}" type="datetimeFigureOut">
              <a:rPr kumimoji="1" lang="ja-JP" altLang="en-US" smtClean="0"/>
              <a:t>2021/6/14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2279A8-DCD9-4E32-ABFF-46F947C2A06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2938519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070D732-52B1-42CB-AD8C-2DC684696488}" type="datetimeFigureOut">
              <a:rPr kumimoji="1" lang="ja-JP" altLang="en-US" smtClean="0"/>
              <a:t>2021/6/1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D2279A8-DCD9-4E32-ABFF-46F947C2A06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2986150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xmlns="" id="{58030CC4-BF3F-404F-84B2-EA029777A645}"/>
              </a:ext>
            </a:extLst>
          </p:cNvPr>
          <p:cNvSpPr txBox="1"/>
          <p:nvPr/>
        </p:nvSpPr>
        <p:spPr>
          <a:xfrm>
            <a:off x="5881077" y="0"/>
            <a:ext cx="97692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Table </a:t>
            </a:r>
            <a:r>
              <a:rPr kumimoji="1" lang="en-US" altLang="ja-JP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S1</a:t>
            </a:r>
            <a:endParaRPr kumimoji="1"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6" name="コンテンツ プレースホルダー 3">
            <a:extLst>
              <a:ext uri="{FF2B5EF4-FFF2-40B4-BE49-F238E27FC236}">
                <a16:creationId xmlns:a16="http://schemas.microsoft.com/office/drawing/2014/main" xmlns="" id="{954405BC-EE07-4E3D-9C54-C5DF51D678B7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679643066"/>
              </p:ext>
            </p:extLst>
          </p:nvPr>
        </p:nvGraphicFramePr>
        <p:xfrm>
          <a:off x="213782" y="678336"/>
          <a:ext cx="6430423" cy="8164326"/>
        </p:xfrm>
        <a:graphic>
          <a:graphicData uri="http://schemas.openxmlformats.org/drawingml/2006/table">
            <a:tbl>
              <a:tblPr firstRow="1" firstCol="1" bandRow="1">
                <a:tableStyleId>{2D5ABB26-0587-4C30-8999-92F81FD0307C}</a:tableStyleId>
              </a:tblPr>
              <a:tblGrid>
                <a:gridCol w="641273">
                  <a:extLst>
                    <a:ext uri="{9D8B030D-6E8A-4147-A177-3AD203B41FA5}">
                      <a16:colId xmlns:a16="http://schemas.microsoft.com/office/drawing/2014/main" xmlns="" val="3649132301"/>
                    </a:ext>
                  </a:extLst>
                </a:gridCol>
                <a:gridCol w="1652228">
                  <a:extLst>
                    <a:ext uri="{9D8B030D-6E8A-4147-A177-3AD203B41FA5}">
                      <a16:colId xmlns:a16="http://schemas.microsoft.com/office/drawing/2014/main" xmlns="" val="228282170"/>
                    </a:ext>
                  </a:extLst>
                </a:gridCol>
                <a:gridCol w="1646206">
                  <a:extLst>
                    <a:ext uri="{9D8B030D-6E8A-4147-A177-3AD203B41FA5}">
                      <a16:colId xmlns:a16="http://schemas.microsoft.com/office/drawing/2014/main" xmlns="" val="2791336391"/>
                    </a:ext>
                  </a:extLst>
                </a:gridCol>
                <a:gridCol w="1719618">
                  <a:extLst>
                    <a:ext uri="{9D8B030D-6E8A-4147-A177-3AD203B41FA5}">
                      <a16:colId xmlns:a16="http://schemas.microsoft.com/office/drawing/2014/main" xmlns="" val="2547229192"/>
                    </a:ext>
                  </a:extLst>
                </a:gridCol>
                <a:gridCol w="771098"/>
              </a:tblGrid>
              <a:tr h="173139">
                <a:tc gridSpan="4">
                  <a:txBody>
                    <a:bodyPr/>
                    <a:lstStyle/>
                    <a:p>
                      <a:pPr algn="just"/>
                      <a:r>
                        <a:rPr lang="en-US" altLang="ja-JP" sz="1000" b="1" kern="100" dirty="0" smtClean="0">
                          <a:effectLst/>
                          <a:latin typeface="Times New Roman" panose="02020603050405020304" pitchFamily="18" charset="0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Supplementary Table S1</a:t>
                      </a:r>
                      <a:r>
                        <a:rPr lang="en-US" altLang="ja-JP" sz="1000" kern="100" dirty="0" smtClean="0">
                          <a:effectLst/>
                          <a:latin typeface="Times New Roman" panose="02020603050405020304" pitchFamily="18" charset="0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  </a:t>
                      </a:r>
                      <a:r>
                        <a:rPr kumimoji="1" lang="en-US" altLang="ja-JP" sz="1000" kern="120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Primer sets used in this study</a:t>
                      </a:r>
                      <a:endParaRPr lang="ja-JP" sz="1000" kern="100" dirty="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25419" marR="25419" marT="0" marB="0" anchor="ctr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endParaRPr lang="ja-JP" sz="1000" kern="10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25419" marR="25419" marT="0" marB="0" anchor="ctr"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endParaRPr lang="ja-JP" sz="1000" kern="10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25419" marR="25419" marT="0" marB="0" anchor="ctr"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endParaRPr lang="ja-JP" sz="1000" kern="100" dirty="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25419" marR="25419" marT="0" marB="0" anchor="ctr"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/>
                      <a:endParaRPr lang="ja-JP" sz="700" kern="100" dirty="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25419" marR="25419" marT="0" marB="0" anchor="ctr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xmlns="" val="4186207420"/>
                  </a:ext>
                </a:extLst>
              </a:tr>
              <a:tr h="173139">
                <a:tc>
                  <a:txBody>
                    <a:bodyPr/>
                    <a:lstStyle/>
                    <a:p>
                      <a:pPr algn="l"/>
                      <a:r>
                        <a:rPr lang="en-US" altLang="ja-JP" sz="700" kern="100" dirty="0" smtClean="0">
                          <a:effectLst/>
                          <a:latin typeface="Times New Roman" panose="02020603050405020304" pitchFamily="18" charset="0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 Gene</a:t>
                      </a:r>
                      <a:endParaRPr lang="ja-JP" sz="700" kern="100" dirty="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25419" marR="25419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700" kern="0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rimer usage</a:t>
                      </a:r>
                      <a:endParaRPr lang="ja-JP" sz="700" kern="100" dirty="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25419" marR="25419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700" kern="0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W primer</a:t>
                      </a:r>
                      <a:endParaRPr lang="ja-JP" sz="700" kern="100" dirty="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25419" marR="25419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altLang="ja-JP" sz="700" kern="0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V primer</a:t>
                      </a:r>
                      <a:endParaRPr lang="ja-JP" sz="700" kern="100" dirty="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25419" marR="25419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altLang="ja-JP" sz="700" kern="100" dirty="0" smtClean="0">
                          <a:effectLst/>
                          <a:latin typeface="Times New Roman" panose="02020603050405020304" pitchFamily="18" charset="0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Reference</a:t>
                      </a:r>
                      <a:endParaRPr lang="ja-JP" sz="700" kern="100" dirty="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25419" marR="25419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853734624"/>
                  </a:ext>
                </a:extLst>
              </a:tr>
              <a:tr h="244314"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altLang="ja-JP" sz="700" i="1" kern="100" dirty="0" smtClean="0">
                          <a:effectLst/>
                          <a:latin typeface="Times New Roman" panose="02020603050405020304" pitchFamily="18" charset="0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GmPR1</a:t>
                      </a:r>
                      <a:endParaRPr lang="ja-JP" sz="700" i="1" kern="100" dirty="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25419" marR="25419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altLang="ja-JP" sz="700" kern="0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xpression analysis for </a:t>
                      </a:r>
                      <a:r>
                        <a:rPr lang="en-US" altLang="ja-JP" sz="700" i="0" kern="0" baseline="0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oybean</a:t>
                      </a:r>
                      <a:endParaRPr lang="ja-JP" altLang="ja-JP" sz="700" i="0" kern="100" dirty="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25419" marR="25419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altLang="ja-JP" sz="700" kern="100" dirty="0" smtClean="0">
                          <a:effectLst/>
                          <a:latin typeface="Times New Roman" panose="02020603050405020304" pitchFamily="18" charset="0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TGATGTTGCCTACGCTCAAG</a:t>
                      </a:r>
                      <a:endParaRPr lang="ja-JP" altLang="ja-JP" sz="700" i="0" kern="100" dirty="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25419" marR="25419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altLang="ja-JP" sz="700" kern="100" dirty="0" smtClean="0">
                          <a:effectLst/>
                          <a:latin typeface="Times New Roman" panose="02020603050405020304" pitchFamily="18" charset="0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AAGCAGCAACCGTATCATCC</a:t>
                      </a:r>
                      <a:endParaRPr lang="ja-JP" sz="700" kern="100" dirty="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25419" marR="25419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altLang="ja-JP" sz="700" kern="100" dirty="0" smtClean="0">
                          <a:effectLst/>
                          <a:latin typeface="Times New Roman" panose="02020603050405020304" pitchFamily="18" charset="0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Mena et al., 2020</a:t>
                      </a:r>
                    </a:p>
                  </a:txBody>
                  <a:tcPr marL="25419" marR="25419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</a:tr>
              <a:tr h="244314"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altLang="ja-JP" sz="700" i="1" kern="100" dirty="0" smtClean="0">
                          <a:effectLst/>
                          <a:latin typeface="Times New Roman" panose="02020603050405020304" pitchFamily="18" charset="0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GmPR2</a:t>
                      </a:r>
                    </a:p>
                  </a:txBody>
                  <a:tcPr marL="25419" marR="25419" marT="0" marB="0" anchor="ctr"/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altLang="ja-JP" sz="700" kern="0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xpression analysis for </a:t>
                      </a:r>
                      <a:r>
                        <a:rPr lang="en-US" altLang="ja-JP" sz="700" i="0" kern="0" baseline="0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oybean</a:t>
                      </a:r>
                      <a:endParaRPr lang="ja-JP" altLang="ja-JP" sz="700" i="0" kern="100" dirty="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25419" marR="25419" marT="0" marB="0" anchor="ctr"/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altLang="ja-JP" sz="700" i="0" kern="100" dirty="0" smtClean="0">
                          <a:effectLst/>
                          <a:latin typeface="Times New Roman" panose="02020603050405020304" pitchFamily="18" charset="0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GTCTCCTTCGGTGGTAGTG</a:t>
                      </a:r>
                      <a:endParaRPr lang="ja-JP" altLang="ja-JP" sz="700" i="0" kern="100" dirty="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25419" marR="25419" marT="0" marB="0" anchor="ctr"/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altLang="ja-JP" sz="700" kern="100" dirty="0" smtClean="0">
                          <a:effectLst/>
                          <a:latin typeface="Times New Roman" panose="02020603050405020304" pitchFamily="18" charset="0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GTCTCCTTCGGTGGTAGTG</a:t>
                      </a:r>
                      <a:endParaRPr lang="ja-JP" sz="700" kern="100" dirty="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25419" marR="25419" marT="0" marB="0" anchor="ctr"/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altLang="ja-JP" sz="700" kern="100" smtClean="0">
                          <a:effectLst/>
                          <a:latin typeface="Times New Roman" panose="02020603050405020304" pitchFamily="18" charset="0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Mena et al., 2020</a:t>
                      </a:r>
                      <a:endParaRPr lang="en-US" altLang="ja-JP" sz="700" kern="100" dirty="0" smtClean="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25419" marR="25419" marT="0" marB="0" anchor="ctr"/>
                </a:tc>
              </a:tr>
              <a:tr h="244314"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altLang="ja-JP" sz="700" i="1" kern="100" dirty="0" smtClean="0">
                          <a:effectLst/>
                          <a:latin typeface="Times New Roman" panose="02020603050405020304" pitchFamily="18" charset="0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GmPR3</a:t>
                      </a:r>
                      <a:endParaRPr lang="ja-JP" sz="700" i="1" kern="100" dirty="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25419" marR="25419" marT="0" marB="0" anchor="ctr"/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altLang="ja-JP" sz="700" kern="0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xpression analysis for </a:t>
                      </a:r>
                      <a:r>
                        <a:rPr lang="en-US" altLang="ja-JP" sz="700" i="0" kern="0" baseline="0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oybean</a:t>
                      </a:r>
                      <a:endParaRPr lang="ja-JP" altLang="ja-JP" sz="700" i="0" kern="100" dirty="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25419" marR="25419" marT="0" marB="0" anchor="ctr"/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altLang="ja-JP" sz="700" i="0" kern="100" dirty="0" smtClean="0">
                          <a:effectLst/>
                          <a:latin typeface="Times New Roman" panose="02020603050405020304" pitchFamily="18" charset="0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GCACTTGGTCTGGATTTG</a:t>
                      </a:r>
                      <a:endParaRPr lang="ja-JP" altLang="ja-JP" sz="700" i="0" kern="100" dirty="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25419" marR="25419" marT="0" marB="0" anchor="ctr"/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altLang="ja-JP" sz="700" kern="100" dirty="0" smtClean="0">
                          <a:effectLst/>
                          <a:latin typeface="Times New Roman" panose="02020603050405020304" pitchFamily="18" charset="0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GGCTTGATGGCTTGTTTC</a:t>
                      </a:r>
                      <a:endParaRPr lang="ja-JP" sz="700" kern="100" dirty="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25419" marR="25419" marT="0" marB="0" anchor="ctr"/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altLang="ja-JP" sz="700" kern="100" smtClean="0">
                          <a:effectLst/>
                          <a:latin typeface="Times New Roman" panose="02020603050405020304" pitchFamily="18" charset="0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Mena et al., 2020</a:t>
                      </a:r>
                      <a:endParaRPr lang="en-US" altLang="ja-JP" sz="700" kern="100" dirty="0" smtClean="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25419" marR="25419" marT="0" marB="0" anchor="ctr"/>
                </a:tc>
              </a:tr>
              <a:tr h="244314"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altLang="ja-JP" sz="700" i="1" kern="100" dirty="0" smtClean="0">
                          <a:effectLst/>
                          <a:latin typeface="Times New Roman" panose="02020603050405020304" pitchFamily="18" charset="0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GmPR4</a:t>
                      </a:r>
                      <a:endParaRPr lang="ja-JP" sz="700" i="1" kern="100" dirty="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25419" marR="25419" marT="0" marB="0" anchor="ctr"/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altLang="ja-JP" sz="700" kern="0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xpression analysis for </a:t>
                      </a:r>
                      <a:r>
                        <a:rPr lang="en-US" altLang="ja-JP" sz="700" i="0" kern="0" baseline="0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oybean</a:t>
                      </a:r>
                      <a:endParaRPr lang="ja-JP" altLang="ja-JP" sz="700" i="0" kern="100" dirty="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25419" marR="25419" marT="0" marB="0" anchor="ctr"/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altLang="ja-JP" sz="700" i="0" kern="100" dirty="0" smtClean="0">
                          <a:effectLst/>
                          <a:latin typeface="Times New Roman" panose="02020603050405020304" pitchFamily="18" charset="0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GCTTGCGGGTGACAAATAC</a:t>
                      </a:r>
                      <a:endParaRPr lang="ja-JP" altLang="ja-JP" sz="700" i="0" kern="100" dirty="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25419" marR="25419" marT="0" marB="0" anchor="ctr"/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altLang="ja-JP" sz="700" kern="100" dirty="0" smtClean="0">
                          <a:effectLst/>
                          <a:latin typeface="Times New Roman" panose="02020603050405020304" pitchFamily="18" charset="0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ACACTCCCACGTCCAAATC</a:t>
                      </a:r>
                      <a:endParaRPr lang="ja-JP" sz="700" kern="100" dirty="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25419" marR="25419" marT="0" marB="0" anchor="ctr"/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altLang="ja-JP" sz="700" kern="100" smtClean="0">
                          <a:effectLst/>
                          <a:latin typeface="Times New Roman" panose="02020603050405020304" pitchFamily="18" charset="0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Mena et al., 2020</a:t>
                      </a:r>
                      <a:endParaRPr lang="en-US" altLang="ja-JP" sz="700" kern="100" dirty="0" smtClean="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25419" marR="25419" marT="0" marB="0" anchor="ctr"/>
                </a:tc>
              </a:tr>
              <a:tr h="244314"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altLang="ja-JP" sz="700" i="1" kern="100" dirty="0" smtClean="0">
                          <a:effectLst/>
                          <a:latin typeface="Times New Roman" panose="02020603050405020304" pitchFamily="18" charset="0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GmPR10</a:t>
                      </a:r>
                      <a:endParaRPr lang="ja-JP" sz="700" i="1" kern="100" dirty="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25419" marR="25419" marT="0" marB="0" anchor="ctr"/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altLang="ja-JP" sz="700" kern="0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xpression analysis for </a:t>
                      </a:r>
                      <a:r>
                        <a:rPr lang="en-US" altLang="ja-JP" sz="700" i="0" kern="0" baseline="0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oybean</a:t>
                      </a:r>
                      <a:endParaRPr lang="ja-JP" altLang="ja-JP" sz="700" i="0" kern="100" dirty="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25419" marR="25419" marT="0" marB="0" anchor="ctr"/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altLang="ja-JP" sz="700" i="0" kern="100" dirty="0" smtClean="0">
                          <a:effectLst/>
                          <a:latin typeface="Times New Roman" panose="02020603050405020304" pitchFamily="18" charset="0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GCCCAGGAACCATCAAGAAG</a:t>
                      </a:r>
                      <a:endParaRPr lang="ja-JP" altLang="ja-JP" sz="700" i="0" kern="100" dirty="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25419" marR="25419" marT="0" marB="0" anchor="ctr"/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altLang="ja-JP" sz="700" kern="100" dirty="0" smtClean="0">
                          <a:effectLst/>
                          <a:latin typeface="Times New Roman" panose="02020603050405020304" pitchFamily="18" charset="0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CGCTGTAGCTGTATCCCAAG</a:t>
                      </a:r>
                      <a:endParaRPr lang="ja-JP" sz="700" kern="100" dirty="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25419" marR="25419" marT="0" marB="0" anchor="ctr"/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altLang="ja-JP" sz="700" kern="100" dirty="0" smtClean="0">
                          <a:effectLst/>
                          <a:latin typeface="Times New Roman" panose="02020603050405020304" pitchFamily="18" charset="0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Mena et al., 2020</a:t>
                      </a:r>
                    </a:p>
                  </a:txBody>
                  <a:tcPr marL="25419" marR="25419" marT="0" marB="0" anchor="ctr"/>
                </a:tc>
              </a:tr>
              <a:tr h="244314"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altLang="ja-JP" sz="700" i="1" kern="100" dirty="0" err="1" smtClean="0">
                          <a:effectLst/>
                          <a:latin typeface="Times New Roman" panose="02020603050405020304" pitchFamily="18" charset="0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GmPAL</a:t>
                      </a:r>
                      <a:endParaRPr lang="ja-JP" sz="700" i="1" kern="100" dirty="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25419" marR="25419" marT="0" marB="0" anchor="ctr"/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altLang="ja-JP" sz="700" kern="0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xpression analysis for </a:t>
                      </a:r>
                      <a:r>
                        <a:rPr lang="en-US" altLang="ja-JP" sz="700" i="0" kern="0" baseline="0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oybean</a:t>
                      </a:r>
                      <a:endParaRPr lang="ja-JP" altLang="ja-JP" sz="700" i="0" kern="100" dirty="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25419" marR="25419" marT="0" marB="0" anchor="ctr"/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altLang="ja-JP" sz="700" i="0" kern="100" dirty="0" smtClean="0">
                          <a:effectLst/>
                          <a:latin typeface="Times New Roman" panose="02020603050405020304" pitchFamily="18" charset="0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GTGCAAGGGCTGCTTATG</a:t>
                      </a:r>
                      <a:endParaRPr lang="ja-JP" altLang="ja-JP" sz="700" i="0" kern="100" dirty="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25419" marR="25419" marT="0" marB="0" anchor="ctr"/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altLang="ja-JP" sz="700" kern="100" dirty="0" smtClean="0">
                          <a:effectLst/>
                          <a:latin typeface="Times New Roman" panose="02020603050405020304" pitchFamily="18" charset="0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CCCAGTCCCTAATTCCTCTC</a:t>
                      </a:r>
                      <a:endParaRPr lang="ja-JP" sz="700" kern="100" dirty="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25419" marR="25419" marT="0" marB="0" anchor="ctr"/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700" kern="100" dirty="0" smtClean="0">
                          <a:effectLst/>
                          <a:latin typeface="Times New Roman" panose="02020603050405020304" pitchFamily="18" charset="0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Mena et al., 2020</a:t>
                      </a:r>
                    </a:p>
                  </a:txBody>
                  <a:tcPr marL="25419" marR="25419" marT="0" marB="0" anchor="ctr"/>
                </a:tc>
              </a:tr>
              <a:tr h="244314"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altLang="ja-JP" sz="700" i="1" kern="100" dirty="0" smtClean="0">
                          <a:effectLst/>
                          <a:latin typeface="Times New Roman" panose="02020603050405020304" pitchFamily="18" charset="0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GmC4H</a:t>
                      </a:r>
                      <a:endParaRPr lang="ja-JP" sz="700" i="1" kern="100" dirty="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25419" marR="25419" marT="0" marB="0" anchor="ctr"/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altLang="ja-JP" sz="700" kern="0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xpression analysis for </a:t>
                      </a:r>
                      <a:r>
                        <a:rPr lang="en-US" altLang="ja-JP" sz="700" i="0" kern="0" baseline="0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oybean</a:t>
                      </a:r>
                      <a:endParaRPr lang="ja-JP" altLang="ja-JP" sz="700" i="0" kern="100" dirty="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25419" marR="25419" marT="0" marB="0" anchor="ctr"/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altLang="ja-JP" sz="700" i="0" kern="100" dirty="0" smtClean="0">
                          <a:effectLst/>
                          <a:latin typeface="Times New Roman" panose="02020603050405020304" pitchFamily="18" charset="0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ATCACTTTGGGACGTTTGG</a:t>
                      </a:r>
                      <a:endParaRPr lang="ja-JP" altLang="ja-JP" sz="700" i="0" kern="100" dirty="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25419" marR="25419" marT="0" marB="0" anchor="ctr"/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altLang="ja-JP" sz="700" kern="100" dirty="0" smtClean="0">
                          <a:effectLst/>
                          <a:latin typeface="Times New Roman" panose="02020603050405020304" pitchFamily="18" charset="0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CACAATGGTGGAATGCTTGAG</a:t>
                      </a:r>
                      <a:endParaRPr lang="ja-JP" sz="700" kern="100" dirty="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25419" marR="25419" marT="0" marB="0" anchor="ctr"/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altLang="ja-JP" sz="700" kern="100" smtClean="0">
                          <a:effectLst/>
                          <a:latin typeface="Times New Roman" panose="02020603050405020304" pitchFamily="18" charset="0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Beyer</a:t>
                      </a:r>
                      <a:r>
                        <a:rPr lang="en-US" altLang="ja-JP" sz="700" kern="100" baseline="0" smtClean="0">
                          <a:effectLst/>
                          <a:latin typeface="Times New Roman" panose="02020603050405020304" pitchFamily="18" charset="0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 et al., 2019</a:t>
                      </a:r>
                      <a:endParaRPr lang="en-US" altLang="ja-JP" sz="700" kern="100" dirty="0" smtClean="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25419" marR="25419" marT="0" marB="0" anchor="ctr"/>
                </a:tc>
              </a:tr>
              <a:tr h="244314"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altLang="ja-JP" sz="700" i="1" kern="100" dirty="0" smtClean="0">
                          <a:effectLst/>
                          <a:latin typeface="Times New Roman" panose="02020603050405020304" pitchFamily="18" charset="0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Gm4CL</a:t>
                      </a:r>
                      <a:endParaRPr lang="ja-JP" sz="700" i="1" kern="100" dirty="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25419" marR="25419" marT="0" marB="0" anchor="ctr"/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altLang="ja-JP" sz="700" kern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xpression analysis for </a:t>
                      </a:r>
                      <a:r>
                        <a:rPr lang="en-US" altLang="ja-JP" sz="700" i="0" kern="0" baseline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oybean</a:t>
                      </a:r>
                      <a:endParaRPr lang="ja-JP" altLang="ja-JP" sz="700" i="0" kern="100" dirty="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25419" marR="25419" marT="0" marB="0" anchor="ctr"/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altLang="ja-JP" sz="700" i="0" kern="100" dirty="0" smtClean="0">
                          <a:effectLst/>
                          <a:latin typeface="Times New Roman" panose="02020603050405020304" pitchFamily="18" charset="0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TTGCCTTATTCTTCGGGAAC</a:t>
                      </a:r>
                      <a:endParaRPr lang="ja-JP" altLang="ja-JP" sz="700" i="0" kern="100" dirty="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25419" marR="25419" marT="0" marB="0" anchor="ctr"/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altLang="ja-JP" sz="700" kern="100" dirty="0" smtClean="0">
                          <a:effectLst/>
                          <a:latin typeface="Times New Roman" panose="02020603050405020304" pitchFamily="18" charset="0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TTGGGATTATCACCGTCAAC</a:t>
                      </a:r>
                      <a:endParaRPr lang="ja-JP" sz="700" kern="100" dirty="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25419" marR="25419" marT="0" marB="0" anchor="ctr"/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altLang="ja-JP" sz="700" kern="100" smtClean="0">
                          <a:effectLst/>
                          <a:latin typeface="Times New Roman" panose="02020603050405020304" pitchFamily="18" charset="0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Beyer</a:t>
                      </a:r>
                      <a:r>
                        <a:rPr lang="en-US" altLang="ja-JP" sz="700" kern="100" baseline="0" smtClean="0">
                          <a:effectLst/>
                          <a:latin typeface="Times New Roman" panose="02020603050405020304" pitchFamily="18" charset="0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 et al., 2019</a:t>
                      </a:r>
                      <a:endParaRPr lang="en-US" altLang="ja-JP" sz="700" kern="100" dirty="0" smtClean="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25419" marR="25419" marT="0" marB="0" anchor="ctr"/>
                </a:tc>
              </a:tr>
              <a:tr h="244314"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altLang="ja-JP" sz="700" i="1" kern="100" dirty="0" err="1" smtClean="0">
                          <a:effectLst/>
                          <a:latin typeface="Times New Roman" panose="02020603050405020304" pitchFamily="18" charset="0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GmCCoAOMT</a:t>
                      </a:r>
                      <a:endParaRPr lang="ja-JP" sz="700" i="1" kern="100" dirty="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25419" marR="25419" marT="0" marB="0" anchor="ctr"/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altLang="ja-JP" sz="700" kern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xpression analysis for </a:t>
                      </a:r>
                      <a:r>
                        <a:rPr lang="en-US" altLang="ja-JP" sz="700" i="0" kern="0" baseline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oybean</a:t>
                      </a:r>
                      <a:endParaRPr lang="ja-JP" altLang="ja-JP" sz="700" i="0" kern="100" dirty="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25419" marR="25419" marT="0" marB="0" anchor="ctr"/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altLang="ja-JP" sz="700" i="0" kern="100" dirty="0" smtClean="0">
                          <a:effectLst/>
                          <a:latin typeface="Times New Roman" panose="02020603050405020304" pitchFamily="18" charset="0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TTGGAACCTGATGGCTACAC</a:t>
                      </a:r>
                      <a:endParaRPr lang="ja-JP" altLang="ja-JP" sz="700" i="0" kern="100" dirty="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25419" marR="25419" marT="0" marB="0" anchor="ctr"/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altLang="ja-JP" sz="700" kern="100" dirty="0" smtClean="0">
                          <a:effectLst/>
                          <a:latin typeface="Times New Roman" panose="02020603050405020304" pitchFamily="18" charset="0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GTGGAAAGCAAGGAGTAACC</a:t>
                      </a:r>
                      <a:endParaRPr lang="ja-JP" sz="700" kern="100" dirty="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25419" marR="25419" marT="0" marB="0" anchor="ctr"/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altLang="ja-JP" sz="700" kern="100" dirty="0" smtClean="0">
                          <a:effectLst/>
                          <a:latin typeface="Times New Roman" panose="02020603050405020304" pitchFamily="18" charset="0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Beyer</a:t>
                      </a:r>
                      <a:r>
                        <a:rPr lang="en-US" altLang="ja-JP" sz="700" kern="100" baseline="0" dirty="0" smtClean="0">
                          <a:effectLst/>
                          <a:latin typeface="Times New Roman" panose="02020603050405020304" pitchFamily="18" charset="0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 et al., 2019</a:t>
                      </a:r>
                      <a:endParaRPr lang="en-US" altLang="ja-JP" sz="700" kern="100" dirty="0" smtClean="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25419" marR="25419" marT="0" marB="0" anchor="ctr"/>
                </a:tc>
              </a:tr>
              <a:tr h="244314"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altLang="ja-JP" sz="700" i="1" kern="100" dirty="0" err="1" smtClean="0">
                          <a:effectLst/>
                          <a:latin typeface="Times New Roman" panose="02020603050405020304" pitchFamily="18" charset="0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GmCHS</a:t>
                      </a:r>
                      <a:endParaRPr lang="ja-JP" sz="700" i="1" kern="100" dirty="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25419" marR="25419" marT="0" marB="0" anchor="ctr"/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altLang="ja-JP" sz="700" kern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xpression analysis for </a:t>
                      </a:r>
                      <a:r>
                        <a:rPr lang="en-US" altLang="ja-JP" sz="700" i="0" kern="0" baseline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oybean</a:t>
                      </a:r>
                      <a:endParaRPr lang="ja-JP" altLang="ja-JP" sz="700" i="0" kern="100" dirty="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25419" marR="25419" marT="0" marB="0" anchor="ctr"/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altLang="ja-JP" sz="700" i="0" kern="100" dirty="0" smtClean="0">
                          <a:effectLst/>
                          <a:latin typeface="Times New Roman" panose="02020603050405020304" pitchFamily="18" charset="0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AGGCTGCAACTAAGGCAATC</a:t>
                      </a:r>
                      <a:endParaRPr lang="ja-JP" altLang="ja-JP" sz="700" i="0" kern="100" dirty="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25419" marR="25419" marT="0" marB="0" anchor="ctr"/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altLang="ja-JP" sz="700" kern="100" dirty="0" smtClean="0">
                          <a:effectLst/>
                          <a:latin typeface="Times New Roman" panose="02020603050405020304" pitchFamily="18" charset="0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TAATCAGCACCAGGCATGTC</a:t>
                      </a:r>
                      <a:endParaRPr lang="ja-JP" sz="700" kern="100" dirty="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25419" marR="25419" marT="0" marB="0" anchor="ctr"/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700" kern="100" dirty="0" smtClean="0">
                          <a:effectLst/>
                          <a:latin typeface="Times New Roman" panose="02020603050405020304" pitchFamily="18" charset="0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Mena et al., 2020</a:t>
                      </a:r>
                    </a:p>
                  </a:txBody>
                  <a:tcPr marL="25419" marR="25419" marT="0" marB="0" anchor="ctr"/>
                </a:tc>
              </a:tr>
              <a:tr h="244314"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altLang="ja-JP" sz="700" i="1" kern="100" dirty="0" err="1" smtClean="0">
                          <a:effectLst/>
                          <a:latin typeface="Times New Roman" panose="02020603050405020304" pitchFamily="18" charset="0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GmCHR</a:t>
                      </a:r>
                      <a:endParaRPr lang="ja-JP" sz="700" i="1" kern="100" dirty="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25419" marR="25419" marT="0" marB="0" anchor="ctr"/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altLang="ja-JP" sz="700" kern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xpression analysis for </a:t>
                      </a:r>
                      <a:r>
                        <a:rPr lang="en-US" altLang="ja-JP" sz="700" i="0" kern="0" baseline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oybean</a:t>
                      </a:r>
                      <a:endParaRPr lang="ja-JP" altLang="ja-JP" sz="700" i="0" kern="100" dirty="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25419" marR="25419" marT="0" marB="0" anchor="ctr"/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altLang="ja-JP" sz="700" i="0" kern="100" dirty="0" smtClean="0">
                          <a:effectLst/>
                          <a:latin typeface="Times New Roman" panose="02020603050405020304" pitchFamily="18" charset="0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CCAGTGAGGCTGAGACATGA</a:t>
                      </a:r>
                      <a:endParaRPr lang="ja-JP" altLang="ja-JP" sz="700" i="0" kern="100" dirty="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25419" marR="25419" marT="0" marB="0" anchor="ctr"/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altLang="ja-JP" sz="700" kern="100" dirty="0" smtClean="0">
                          <a:effectLst/>
                          <a:latin typeface="Times New Roman" panose="02020603050405020304" pitchFamily="18" charset="0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ATTGACTGCAGGAGGAATGG</a:t>
                      </a:r>
                      <a:endParaRPr lang="ja-JP" sz="700" kern="100" dirty="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25419" marR="25419" marT="0" marB="0" anchor="ctr"/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altLang="ja-JP" sz="700" kern="100" dirty="0" smtClean="0">
                          <a:effectLst/>
                          <a:latin typeface="Times New Roman" panose="02020603050405020304" pitchFamily="18" charset="0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Hossain et al., 2018</a:t>
                      </a:r>
                    </a:p>
                  </a:txBody>
                  <a:tcPr marL="25419" marR="25419" marT="0" marB="0" anchor="ctr"/>
                </a:tc>
              </a:tr>
              <a:tr h="244314"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altLang="ja-JP" sz="700" i="1" kern="100" dirty="0" err="1" smtClean="0">
                          <a:effectLst/>
                          <a:latin typeface="Times New Roman" panose="02020603050405020304" pitchFamily="18" charset="0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GmCHI</a:t>
                      </a:r>
                      <a:endParaRPr lang="ja-JP" sz="700" i="1" kern="100" dirty="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25419" marR="25419" marT="0" marB="0" anchor="ctr"/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altLang="ja-JP" sz="700" kern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xpression analysis for </a:t>
                      </a:r>
                      <a:r>
                        <a:rPr lang="en-US" altLang="ja-JP" sz="700" i="0" kern="0" baseline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oybean</a:t>
                      </a:r>
                      <a:endParaRPr lang="ja-JP" altLang="ja-JP" sz="700" i="0" kern="100" dirty="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25419" marR="25419" marT="0" marB="0" anchor="ctr"/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altLang="ja-JP" sz="700" i="0" kern="100" dirty="0" smtClean="0">
                          <a:effectLst/>
                          <a:latin typeface="Times New Roman" panose="02020603050405020304" pitchFamily="18" charset="0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CACTGCCATCTGCATTTACC</a:t>
                      </a:r>
                      <a:endParaRPr lang="ja-JP" altLang="ja-JP" sz="700" i="0" kern="100" dirty="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25419" marR="25419" marT="0" marB="0" anchor="ctr"/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altLang="ja-JP" sz="700" kern="100" dirty="0" smtClean="0">
                          <a:effectLst/>
                          <a:latin typeface="Times New Roman" panose="02020603050405020304" pitchFamily="18" charset="0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TCTCGAATGGACCTGTAACG</a:t>
                      </a:r>
                      <a:endParaRPr lang="ja-JP" sz="700" kern="100" dirty="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25419" marR="25419" marT="0" marB="0" anchor="ctr"/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700" kern="100" dirty="0" smtClean="0">
                          <a:effectLst/>
                          <a:latin typeface="Times New Roman" panose="02020603050405020304" pitchFamily="18" charset="0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Mena et al., 2020</a:t>
                      </a:r>
                    </a:p>
                  </a:txBody>
                  <a:tcPr marL="25419" marR="25419" marT="0" marB="0" anchor="ctr"/>
                </a:tc>
              </a:tr>
              <a:tr h="244314"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altLang="ja-JP" sz="700" i="1" kern="100" dirty="0" err="1" smtClean="0">
                          <a:effectLst/>
                          <a:latin typeface="Times New Roman" panose="02020603050405020304" pitchFamily="18" charset="0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GmIFS</a:t>
                      </a:r>
                      <a:endParaRPr lang="ja-JP" sz="700" i="1" kern="100" dirty="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25419" marR="25419" marT="0" marB="0" anchor="ctr"/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altLang="ja-JP" sz="700" kern="0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xpression analysis for </a:t>
                      </a:r>
                      <a:r>
                        <a:rPr lang="en-US" altLang="ja-JP" sz="700" i="0" kern="0" baseline="0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oybean</a:t>
                      </a:r>
                      <a:endParaRPr lang="ja-JP" altLang="ja-JP" sz="700" i="0" kern="100" dirty="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25419" marR="25419" marT="0" marB="0" anchor="ctr"/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altLang="ja-JP" sz="700" i="0" kern="100" dirty="0" smtClean="0">
                          <a:effectLst/>
                          <a:latin typeface="Times New Roman" panose="02020603050405020304" pitchFamily="18" charset="0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TCTCCACTACGCACTCATCG</a:t>
                      </a:r>
                      <a:endParaRPr lang="ja-JP" altLang="ja-JP" sz="700" i="0" kern="100" dirty="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25419" marR="25419" marT="0" marB="0" anchor="ctr"/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altLang="ja-JP" sz="700" kern="100" dirty="0" smtClean="0">
                          <a:effectLst/>
                          <a:latin typeface="Times New Roman" panose="02020603050405020304" pitchFamily="18" charset="0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GCTTCCTCACGAACTTCCAG</a:t>
                      </a:r>
                      <a:endParaRPr lang="ja-JP" sz="700" kern="100" dirty="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25419" marR="25419" marT="0" marB="0" anchor="ctr"/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altLang="ja-JP" sz="700" kern="100" smtClean="0">
                          <a:effectLst/>
                          <a:latin typeface="Times New Roman" panose="02020603050405020304" pitchFamily="18" charset="0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Hossain et al., 2018</a:t>
                      </a:r>
                      <a:endParaRPr lang="en-US" altLang="ja-JP" sz="700" kern="100" dirty="0" smtClean="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25419" marR="25419" marT="0" marB="0" anchor="ctr"/>
                </a:tc>
              </a:tr>
              <a:tr h="244314"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altLang="ja-JP" sz="700" i="1" kern="100" dirty="0" err="1" smtClean="0">
                          <a:effectLst/>
                          <a:latin typeface="Times New Roman" panose="02020603050405020304" pitchFamily="18" charset="0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GmIFR</a:t>
                      </a:r>
                      <a:endParaRPr lang="ja-JP" sz="700" i="1" kern="100" dirty="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25419" marR="25419" marT="0" marB="0" anchor="ctr"/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700" kern="0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xpression analysis for </a:t>
                      </a:r>
                      <a:r>
                        <a:rPr lang="en-US" altLang="ja-JP" sz="700" i="0" kern="0" baseline="0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oybean</a:t>
                      </a:r>
                      <a:endParaRPr lang="ja-JP" altLang="ja-JP" sz="700" i="0" kern="100" dirty="0" smtClean="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25419" marR="25419" marT="0" marB="0" anchor="ctr"/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altLang="ja-JP" sz="700" i="0" kern="100" dirty="0" smtClean="0">
                          <a:effectLst/>
                          <a:latin typeface="Times New Roman" panose="02020603050405020304" pitchFamily="18" charset="0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AGAAAGACTCGGCACTCGAA</a:t>
                      </a:r>
                      <a:endParaRPr lang="ja-JP" altLang="ja-JP" sz="700" i="0" kern="100" dirty="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25419" marR="25419" marT="0" marB="0" anchor="ctr"/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altLang="ja-JP" sz="700" kern="100" dirty="0" smtClean="0">
                          <a:effectLst/>
                          <a:latin typeface="Times New Roman" panose="02020603050405020304" pitchFamily="18" charset="0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TTGACACTACCTCGCCCTCT</a:t>
                      </a:r>
                      <a:endParaRPr lang="ja-JP" sz="700" kern="100" dirty="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25419" marR="25419" marT="0" marB="0" anchor="ctr"/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altLang="ja-JP" sz="700" kern="100" dirty="0" smtClean="0">
                          <a:effectLst/>
                          <a:latin typeface="Times New Roman" panose="02020603050405020304" pitchFamily="18" charset="0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Hossain et al., 2018</a:t>
                      </a:r>
                    </a:p>
                  </a:txBody>
                  <a:tcPr marL="25419" marR="25419" marT="0" marB="0" anchor="ctr"/>
                </a:tc>
              </a:tr>
              <a:tr h="244314"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altLang="ja-JP" sz="700" i="1" kern="100" dirty="0" smtClean="0">
                          <a:effectLst/>
                          <a:latin typeface="Times New Roman" panose="02020603050405020304" pitchFamily="18" charset="0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GmEF1</a:t>
                      </a:r>
                      <a:r>
                        <a:rPr lang="en-US" altLang="ja-JP" sz="700" i="1" kern="100" dirty="0" smtClean="0">
                          <a:effectLst/>
                          <a:latin typeface="Symbol" panose="05050102010706020507" pitchFamily="18" charset="2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a</a:t>
                      </a:r>
                      <a:endParaRPr lang="ja-JP" sz="700" i="1" kern="100" dirty="0">
                        <a:effectLst/>
                        <a:latin typeface="Symbol" panose="05050102010706020507" pitchFamily="18" charset="2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25419" marR="25419" marT="0" marB="0" anchor="ctr"/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700" kern="0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xpression analysis for </a:t>
                      </a:r>
                      <a:r>
                        <a:rPr lang="en-US" altLang="ja-JP" sz="700" i="0" kern="0" baseline="0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oybean</a:t>
                      </a:r>
                      <a:endParaRPr lang="ja-JP" altLang="ja-JP" sz="700" i="0" kern="100" dirty="0" smtClean="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25419" marR="25419" marT="0" marB="0" anchor="ctr"/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altLang="ja-JP" sz="700" i="0" kern="100" dirty="0" smtClean="0">
                          <a:effectLst/>
                          <a:latin typeface="Times New Roman" panose="02020603050405020304" pitchFamily="18" charset="0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GATTTCATGTAGCCGTAGCC</a:t>
                      </a:r>
                      <a:endParaRPr lang="ja-JP" altLang="ja-JP" sz="700" i="0" kern="100" dirty="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25419" marR="25419" marT="0" marB="0" anchor="ctr"/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altLang="ja-JP" sz="700" kern="100" dirty="0" smtClean="0">
                          <a:effectLst/>
                          <a:latin typeface="Times New Roman" panose="02020603050405020304" pitchFamily="18" charset="0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ATTTAAGACATCCCTCCTCAG</a:t>
                      </a:r>
                      <a:endParaRPr lang="ja-JP" sz="700" kern="100" dirty="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25419" marR="25419" marT="0" marB="0" anchor="ctr"/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altLang="ja-JP" sz="700" kern="100" dirty="0" smtClean="0">
                          <a:effectLst/>
                          <a:latin typeface="Times New Roman" panose="02020603050405020304" pitchFamily="18" charset="0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Mena et al., 2020</a:t>
                      </a:r>
                    </a:p>
                  </a:txBody>
                  <a:tcPr marL="25419" marR="25419" marT="0" marB="0" anchor="ctr"/>
                </a:tc>
              </a:tr>
              <a:tr h="244314"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altLang="ja-JP" sz="700" i="1" kern="100" dirty="0" smtClean="0">
                          <a:effectLst/>
                          <a:latin typeface="Times New Roman" panose="02020603050405020304" pitchFamily="18" charset="0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GmUBQ3</a:t>
                      </a:r>
                      <a:endParaRPr lang="ja-JP" sz="700" i="1" kern="100" dirty="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25419" marR="25419" marT="0" marB="0" anchor="ctr"/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altLang="ja-JP" sz="700" kern="0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xpression analysis for</a:t>
                      </a:r>
                      <a:r>
                        <a:rPr lang="en-US" altLang="ja-JP" sz="700" kern="0" baseline="0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n-US" altLang="ja-JP" sz="700" i="0" kern="0" baseline="0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oybean</a:t>
                      </a:r>
                      <a:endParaRPr lang="ja-JP" altLang="ja-JP" sz="700" i="0" kern="100" dirty="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25419" marR="25419" marT="0" marB="0" anchor="ctr"/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altLang="ja-JP" sz="700" kern="100" dirty="0" smtClean="0">
                          <a:effectLst/>
                          <a:latin typeface="Times New Roman" panose="02020603050405020304" pitchFamily="18" charset="0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GATCTACCATGTTCCCAAGT</a:t>
                      </a:r>
                      <a:endParaRPr lang="ja-JP" altLang="ja-JP" sz="700" i="0" kern="100" dirty="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25419" marR="25419" marT="0" marB="0" anchor="ctr"/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altLang="ja-JP" sz="700" kern="100" dirty="0" smtClean="0">
                          <a:effectLst/>
                          <a:latin typeface="Times New Roman" panose="02020603050405020304" pitchFamily="18" charset="0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AGGCTGTTGACTAGGAAGAAAC</a:t>
                      </a:r>
                      <a:endParaRPr lang="ja-JP" sz="700" kern="100" dirty="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25419" marR="25419" marT="0" marB="0" anchor="ctr"/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altLang="ja-JP" sz="700" kern="100" dirty="0" smtClean="0">
                          <a:effectLst/>
                          <a:latin typeface="Times New Roman" panose="02020603050405020304" pitchFamily="18" charset="0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Beyer</a:t>
                      </a:r>
                      <a:r>
                        <a:rPr lang="en-US" altLang="ja-JP" sz="700" kern="100" baseline="0" dirty="0" smtClean="0">
                          <a:effectLst/>
                          <a:latin typeface="Times New Roman" panose="02020603050405020304" pitchFamily="18" charset="0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 et al., 2019</a:t>
                      </a:r>
                      <a:endParaRPr lang="en-US" altLang="ja-JP" sz="700" kern="100" dirty="0" smtClean="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25419" marR="25419" marT="0" marB="0" anchor="ctr"/>
                </a:tc>
              </a:tr>
              <a:tr h="244314"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altLang="ja-JP" sz="700" i="1" kern="100" dirty="0" smtClean="0">
                          <a:effectLst/>
                          <a:latin typeface="Times New Roman" panose="02020603050405020304" pitchFamily="18" charset="0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PpCHS2-1</a:t>
                      </a:r>
                      <a:endParaRPr lang="ja-JP" sz="700" i="1" kern="100" dirty="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25419" marR="25419" marT="0" marB="0" anchor="ctr"/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altLang="ja-JP" sz="700" kern="0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xpression analysis for </a:t>
                      </a:r>
                      <a:r>
                        <a:rPr lang="en-US" altLang="ja-JP" sz="700" i="1" kern="0" baseline="0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. </a:t>
                      </a:r>
                      <a:r>
                        <a:rPr lang="en-US" altLang="ja-JP" sz="700" i="1" kern="0" baseline="0" dirty="0" err="1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achyrhizi</a:t>
                      </a:r>
                      <a:endParaRPr lang="ja-JP" altLang="ja-JP" sz="700" i="0" kern="100" dirty="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25419" marR="25419" marT="0" marB="0" anchor="ctr"/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altLang="ja-JP" sz="700" kern="100" dirty="0" smtClean="0">
                          <a:effectLst/>
                          <a:latin typeface="Times New Roman" panose="02020603050405020304" pitchFamily="18" charset="0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TTCCAAGCTCTGTTGGTATCAG</a:t>
                      </a:r>
                      <a:endParaRPr lang="ja-JP" altLang="ja-JP" sz="700" i="0" kern="100" dirty="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25419" marR="25419" marT="0" marB="0" anchor="ctr"/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altLang="ja-JP" sz="700" kern="100" dirty="0" smtClean="0">
                          <a:effectLst/>
                          <a:latin typeface="Times New Roman" panose="02020603050405020304" pitchFamily="18" charset="0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CATATCTCATCACTCCCATGGAC</a:t>
                      </a:r>
                      <a:endParaRPr lang="ja-JP" sz="700" kern="100" dirty="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25419" marR="25419" marT="0" marB="0" anchor="ctr"/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altLang="ja-JP" sz="700" kern="100" dirty="0" smtClean="0">
                          <a:effectLst/>
                          <a:latin typeface="Times New Roman" panose="02020603050405020304" pitchFamily="18" charset="0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This study</a:t>
                      </a:r>
                      <a:endParaRPr lang="ja-JP" altLang="ja-JP" sz="700" kern="100" dirty="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25419" marR="25419" marT="0" marB="0" anchor="ctr"/>
                </a:tc>
              </a:tr>
              <a:tr h="244314"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altLang="ja-JP" sz="700" i="1" kern="100" dirty="0" smtClean="0">
                          <a:effectLst/>
                          <a:latin typeface="Times New Roman" panose="02020603050405020304" pitchFamily="18" charset="0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PpCHS2-2</a:t>
                      </a:r>
                      <a:endParaRPr lang="ja-JP" sz="700" i="1" kern="100" dirty="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25419" marR="25419" marT="0" marB="0" anchor="ctr"/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altLang="ja-JP" sz="700" kern="0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xpression analysis for </a:t>
                      </a:r>
                      <a:r>
                        <a:rPr lang="en-US" altLang="ja-JP" sz="700" i="1" kern="0" baseline="0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. </a:t>
                      </a:r>
                      <a:r>
                        <a:rPr lang="en-US" altLang="ja-JP" sz="700" i="1" kern="0" baseline="0" dirty="0" err="1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achyrhizi</a:t>
                      </a:r>
                      <a:endParaRPr lang="ja-JP" altLang="ja-JP" sz="700" i="0" kern="100" dirty="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25419" marR="25419" marT="0" marB="0" anchor="ctr"/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altLang="ja-JP" sz="700" kern="100" dirty="0" smtClean="0">
                          <a:effectLst/>
                          <a:latin typeface="Times New Roman" panose="02020603050405020304" pitchFamily="18" charset="0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CCCTGATGTCAGACTCCATAAAC</a:t>
                      </a:r>
                      <a:endParaRPr lang="ja-JP" altLang="ja-JP" sz="700" i="0" kern="100" dirty="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25419" marR="25419" marT="0" marB="0" anchor="ctr"/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altLang="ja-JP" sz="700" kern="100" dirty="0" smtClean="0">
                          <a:effectLst/>
                          <a:latin typeface="Times New Roman" panose="02020603050405020304" pitchFamily="18" charset="0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GTTGAGGGATCCTACCGTATCT</a:t>
                      </a:r>
                      <a:endParaRPr lang="ja-JP" sz="700" kern="100" dirty="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25419" marR="25419" marT="0" marB="0" anchor="ctr"/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altLang="ja-JP" sz="700" kern="100" dirty="0" smtClean="0">
                          <a:effectLst/>
                          <a:latin typeface="Times New Roman" panose="02020603050405020304" pitchFamily="18" charset="0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This study</a:t>
                      </a:r>
                      <a:endParaRPr lang="ja-JP" altLang="ja-JP" sz="700" kern="100" dirty="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25419" marR="25419" marT="0" marB="0" anchor="ctr"/>
                </a:tc>
              </a:tr>
              <a:tr h="244314"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altLang="ja-JP" sz="700" i="1" kern="100" dirty="0" smtClean="0">
                          <a:effectLst/>
                          <a:latin typeface="Times New Roman" panose="02020603050405020304" pitchFamily="18" charset="0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PpCHS2-3</a:t>
                      </a:r>
                      <a:endParaRPr lang="ja-JP" sz="700" i="1" kern="100" dirty="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25419" marR="25419" marT="0" marB="0" anchor="ctr"/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altLang="ja-JP" sz="700" kern="0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xpression analysis for </a:t>
                      </a:r>
                      <a:r>
                        <a:rPr lang="en-US" altLang="ja-JP" sz="700" i="1" kern="0" baseline="0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. </a:t>
                      </a:r>
                      <a:r>
                        <a:rPr lang="en-US" altLang="ja-JP" sz="700" i="1" kern="0" baseline="0" dirty="0" err="1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achyrhizi</a:t>
                      </a:r>
                      <a:endParaRPr lang="ja-JP" altLang="ja-JP" sz="700" i="0" kern="100" dirty="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25419" marR="25419" marT="0" marB="0" anchor="ctr"/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altLang="ja-JP" sz="700" kern="100" dirty="0" smtClean="0">
                          <a:effectLst/>
                          <a:latin typeface="Times New Roman" panose="02020603050405020304" pitchFamily="18" charset="0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CGACCCAAAGAGAGCAAAGA</a:t>
                      </a:r>
                      <a:endParaRPr lang="ja-JP" altLang="ja-JP" sz="700" i="0" kern="100" dirty="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25419" marR="25419" marT="0" marB="0" anchor="ctr"/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altLang="ja-JP" sz="700" kern="100" dirty="0" smtClean="0">
                          <a:effectLst/>
                          <a:latin typeface="Times New Roman" panose="02020603050405020304" pitchFamily="18" charset="0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CTTGTACCCACCGGCTAAAT</a:t>
                      </a:r>
                      <a:endParaRPr lang="ja-JP" sz="700" kern="100" dirty="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25419" marR="25419" marT="0" marB="0" anchor="ctr"/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altLang="ja-JP" sz="700" kern="100" dirty="0" smtClean="0">
                          <a:effectLst/>
                          <a:latin typeface="Times New Roman" panose="02020603050405020304" pitchFamily="18" charset="0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This study</a:t>
                      </a:r>
                      <a:endParaRPr lang="ja-JP" altLang="ja-JP" sz="700" kern="100" dirty="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25419" marR="25419" marT="0" marB="0" anchor="ctr"/>
                </a:tc>
              </a:tr>
              <a:tr h="244314"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altLang="ja-JP" sz="700" i="1" kern="100" dirty="0" smtClean="0">
                          <a:effectLst/>
                          <a:latin typeface="Times New Roman" panose="02020603050405020304" pitchFamily="18" charset="0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PpCHS3-1</a:t>
                      </a:r>
                      <a:endParaRPr lang="ja-JP" sz="700" i="1" kern="100" dirty="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25419" marR="25419" marT="0" marB="0" anchor="ctr"/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altLang="ja-JP" sz="700" kern="0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xpression analysis for </a:t>
                      </a:r>
                      <a:r>
                        <a:rPr lang="en-US" altLang="ja-JP" sz="700" i="1" kern="0" baseline="0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. </a:t>
                      </a:r>
                      <a:r>
                        <a:rPr lang="en-US" altLang="ja-JP" sz="700" i="1" kern="0" baseline="0" dirty="0" err="1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achyrhizi</a:t>
                      </a:r>
                      <a:endParaRPr lang="ja-JP" altLang="ja-JP" sz="700" i="0" kern="100" dirty="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25419" marR="25419" marT="0" marB="0" anchor="ctr"/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altLang="ja-JP" sz="700" kern="100" dirty="0" smtClean="0">
                          <a:effectLst/>
                          <a:latin typeface="Times New Roman" panose="02020603050405020304" pitchFamily="18" charset="0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TCACAACACCCACTCCAATC</a:t>
                      </a:r>
                      <a:endParaRPr lang="ja-JP" altLang="ja-JP" sz="700" i="0" kern="100" dirty="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25419" marR="25419" marT="0" marB="0" anchor="ctr"/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altLang="ja-JP" sz="700" kern="100" dirty="0" smtClean="0">
                          <a:effectLst/>
                          <a:latin typeface="Times New Roman" panose="02020603050405020304" pitchFamily="18" charset="0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CATATCTCATCACTCCCATGGAC</a:t>
                      </a:r>
                      <a:endParaRPr lang="ja-JP" sz="700" kern="100" dirty="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25419" marR="25419" marT="0" marB="0" anchor="ctr"/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altLang="ja-JP" sz="700" kern="100" dirty="0" smtClean="0">
                          <a:effectLst/>
                          <a:latin typeface="Times New Roman" panose="02020603050405020304" pitchFamily="18" charset="0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This study</a:t>
                      </a:r>
                      <a:endParaRPr lang="ja-JP" altLang="ja-JP" sz="700" kern="100" dirty="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25419" marR="25419" marT="0" marB="0" anchor="ctr"/>
                </a:tc>
              </a:tr>
              <a:tr h="244314"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altLang="ja-JP" sz="700" i="1" kern="100" dirty="0" smtClean="0">
                          <a:effectLst/>
                          <a:latin typeface="Times New Roman" panose="02020603050405020304" pitchFamily="18" charset="0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PpCHS3-2</a:t>
                      </a:r>
                      <a:endParaRPr lang="ja-JP" sz="700" i="1" kern="100" dirty="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25419" marR="25419" marT="0" marB="0" anchor="ctr"/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altLang="ja-JP" sz="700" kern="0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xpression analysis for </a:t>
                      </a:r>
                      <a:r>
                        <a:rPr lang="en-US" altLang="ja-JP" sz="700" i="1" kern="0" baseline="0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. </a:t>
                      </a:r>
                      <a:r>
                        <a:rPr lang="en-US" altLang="ja-JP" sz="700" i="1" kern="0" baseline="0" dirty="0" err="1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achyrhizi</a:t>
                      </a:r>
                      <a:endParaRPr lang="ja-JP" altLang="ja-JP" sz="700" i="0" kern="100" dirty="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25419" marR="25419" marT="0" marB="0" anchor="ctr"/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altLang="ja-JP" sz="700" kern="100" dirty="0" smtClean="0">
                          <a:effectLst/>
                          <a:latin typeface="Times New Roman" panose="02020603050405020304" pitchFamily="18" charset="0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CTCTTCTGAGTTGCCGTCTTT</a:t>
                      </a:r>
                      <a:endParaRPr lang="ja-JP" altLang="ja-JP" sz="700" i="0" kern="100" dirty="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25419" marR="25419" marT="0" marB="0" anchor="ctr"/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altLang="ja-JP" sz="700" kern="100" dirty="0" smtClean="0">
                          <a:effectLst/>
                          <a:latin typeface="Times New Roman" panose="02020603050405020304" pitchFamily="18" charset="0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CATATCTCATCACTCCCATGGAC</a:t>
                      </a:r>
                      <a:endParaRPr lang="ja-JP" sz="700" kern="100" dirty="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25419" marR="25419" marT="0" marB="0" anchor="ctr"/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altLang="ja-JP" sz="700" kern="100" dirty="0" smtClean="0">
                          <a:effectLst/>
                          <a:latin typeface="Times New Roman" panose="02020603050405020304" pitchFamily="18" charset="0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This study</a:t>
                      </a:r>
                      <a:endParaRPr lang="ja-JP" altLang="ja-JP" sz="700" kern="100" dirty="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25419" marR="25419" marT="0" marB="0" anchor="ctr"/>
                </a:tc>
              </a:tr>
              <a:tr h="244314"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altLang="ja-JP" sz="700" i="1" kern="100" dirty="0" smtClean="0">
                          <a:effectLst/>
                          <a:latin typeface="Times New Roman" panose="02020603050405020304" pitchFamily="18" charset="0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PpCHS3-3</a:t>
                      </a:r>
                      <a:endParaRPr lang="ja-JP" sz="700" i="1" kern="100" dirty="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25419" marR="25419" marT="0" marB="0" anchor="ctr"/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altLang="ja-JP" sz="700" kern="0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xpression analysis for </a:t>
                      </a:r>
                      <a:r>
                        <a:rPr lang="en-US" altLang="ja-JP" sz="700" i="1" kern="0" baseline="0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. </a:t>
                      </a:r>
                      <a:r>
                        <a:rPr lang="en-US" altLang="ja-JP" sz="700" i="1" kern="0" baseline="0" dirty="0" err="1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achyrhizi</a:t>
                      </a:r>
                      <a:endParaRPr lang="ja-JP" altLang="ja-JP" sz="700" i="0" kern="100" dirty="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25419" marR="25419" marT="0" marB="0" anchor="ctr"/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altLang="ja-JP" sz="700" kern="100" dirty="0" smtClean="0">
                          <a:effectLst/>
                          <a:latin typeface="Times New Roman" panose="02020603050405020304" pitchFamily="18" charset="0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TTCCAAGCTCTGTTGGTATCAG</a:t>
                      </a:r>
                      <a:endParaRPr lang="ja-JP" altLang="ja-JP" sz="700" i="0" kern="100" dirty="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25419" marR="25419" marT="0" marB="0" anchor="ctr"/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altLang="ja-JP" sz="700" kern="100" dirty="0" smtClean="0">
                          <a:effectLst/>
                          <a:latin typeface="Times New Roman" panose="02020603050405020304" pitchFamily="18" charset="0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CATATCTCATCACTCCCATGGAC</a:t>
                      </a:r>
                      <a:endParaRPr lang="ja-JP" sz="700" kern="100" dirty="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25419" marR="25419" marT="0" marB="0" anchor="ctr"/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altLang="ja-JP" sz="700" kern="100" dirty="0" smtClean="0">
                          <a:effectLst/>
                          <a:latin typeface="Times New Roman" panose="02020603050405020304" pitchFamily="18" charset="0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This study</a:t>
                      </a:r>
                      <a:endParaRPr lang="ja-JP" altLang="ja-JP" sz="700" kern="100" dirty="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25419" marR="25419" marT="0" marB="0" anchor="ctr"/>
                </a:tc>
              </a:tr>
              <a:tr h="244314"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altLang="ja-JP" sz="700" i="1" kern="100" dirty="0" smtClean="0">
                          <a:effectLst/>
                          <a:latin typeface="Times New Roman" panose="02020603050405020304" pitchFamily="18" charset="0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PpCHS4</a:t>
                      </a:r>
                      <a:endParaRPr lang="ja-JP" sz="700" i="1" kern="100" dirty="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25419" marR="25419" marT="0" marB="0" anchor="ctr"/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altLang="ja-JP" sz="700" kern="0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xpression analysis for </a:t>
                      </a:r>
                      <a:r>
                        <a:rPr lang="en-US" altLang="ja-JP" sz="700" i="1" kern="0" baseline="0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. </a:t>
                      </a:r>
                      <a:r>
                        <a:rPr lang="en-US" altLang="ja-JP" sz="700" i="1" kern="0" baseline="0" dirty="0" err="1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achyrhizi</a:t>
                      </a:r>
                      <a:endParaRPr lang="ja-JP" altLang="ja-JP" sz="700" i="0" kern="100" dirty="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25419" marR="25419" marT="0" marB="0" anchor="ctr"/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altLang="ja-JP" sz="700" kern="100" dirty="0" smtClean="0">
                          <a:effectLst/>
                          <a:latin typeface="Times New Roman" panose="02020603050405020304" pitchFamily="18" charset="0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CCCTTTGTCCTCAGGTTGATAG</a:t>
                      </a:r>
                      <a:endParaRPr lang="ja-JP" altLang="ja-JP" sz="700" i="0" kern="100" dirty="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25419" marR="25419" marT="0" marB="0" anchor="ctr"/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altLang="ja-JP" sz="700" kern="100" dirty="0" smtClean="0">
                          <a:effectLst/>
                          <a:latin typeface="Times New Roman" panose="02020603050405020304" pitchFamily="18" charset="0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TGAAAGCCCAACCAGAGATAC</a:t>
                      </a:r>
                      <a:endParaRPr lang="ja-JP" sz="700" kern="100" dirty="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25419" marR="25419" marT="0" marB="0" anchor="ctr"/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altLang="ja-JP" sz="700" kern="100" dirty="0" smtClean="0">
                          <a:effectLst/>
                          <a:latin typeface="Times New Roman" panose="02020603050405020304" pitchFamily="18" charset="0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This study</a:t>
                      </a:r>
                      <a:endParaRPr lang="ja-JP" altLang="ja-JP" sz="700" kern="100" dirty="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25419" marR="25419" marT="0" marB="0" anchor="ctr"/>
                </a:tc>
              </a:tr>
              <a:tr h="244314"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altLang="ja-JP" sz="700" i="1" kern="100" dirty="0" smtClean="0">
                          <a:effectLst/>
                          <a:latin typeface="Times New Roman" panose="02020603050405020304" pitchFamily="18" charset="0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PpCHS5-1</a:t>
                      </a:r>
                      <a:endParaRPr lang="ja-JP" sz="700" i="1" kern="100" dirty="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25419" marR="25419" marT="0" marB="0" anchor="ctr"/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altLang="ja-JP" sz="700" kern="0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xpression analysis for </a:t>
                      </a:r>
                      <a:r>
                        <a:rPr lang="en-US" altLang="ja-JP" sz="700" i="1" kern="0" baseline="0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. </a:t>
                      </a:r>
                      <a:r>
                        <a:rPr lang="en-US" altLang="ja-JP" sz="700" i="1" kern="0" baseline="0" dirty="0" err="1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achyrhizi</a:t>
                      </a:r>
                      <a:endParaRPr lang="ja-JP" altLang="ja-JP" sz="700" i="0" kern="100" dirty="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25419" marR="25419" marT="0" marB="0" anchor="ctr"/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altLang="ja-JP" sz="700" kern="100" dirty="0" smtClean="0">
                          <a:effectLst/>
                          <a:latin typeface="Times New Roman" panose="02020603050405020304" pitchFamily="18" charset="0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TCTAGGATGGCTAGCCCATTTGGT</a:t>
                      </a:r>
                      <a:endParaRPr lang="ja-JP" altLang="ja-JP" sz="700" i="0" kern="100" dirty="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25419" marR="25419" marT="0" marB="0" anchor="ctr"/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altLang="ja-JP" sz="700" kern="100" dirty="0" smtClean="0">
                          <a:effectLst/>
                          <a:latin typeface="Times New Roman" panose="02020603050405020304" pitchFamily="18" charset="0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GTGATTGTGTTCAAATCCGCCCGT</a:t>
                      </a:r>
                      <a:endParaRPr lang="ja-JP" sz="700" kern="100" dirty="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25419" marR="25419" marT="0" marB="0" anchor="ctr"/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altLang="ja-JP" sz="700" kern="100" dirty="0" smtClean="0">
                          <a:effectLst/>
                          <a:latin typeface="Times New Roman" panose="02020603050405020304" pitchFamily="18" charset="0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Ishiga et al.,</a:t>
                      </a:r>
                      <a:r>
                        <a:rPr lang="en-US" altLang="ja-JP" sz="700" kern="100" baseline="0" dirty="0" smtClean="0">
                          <a:effectLst/>
                          <a:latin typeface="Times New Roman" panose="02020603050405020304" pitchFamily="18" charset="0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 2013</a:t>
                      </a:r>
                      <a:endParaRPr lang="en-US" altLang="ja-JP" sz="700" kern="100" dirty="0" smtClean="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25419" marR="25419" marT="0" marB="0" anchor="ctr"/>
                </a:tc>
              </a:tr>
              <a:tr h="244314"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altLang="ja-JP" sz="700" i="1" kern="100" smtClean="0">
                          <a:effectLst/>
                          <a:latin typeface="Times New Roman" panose="02020603050405020304" pitchFamily="18" charset="0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PpCHS5-1</a:t>
                      </a:r>
                      <a:endParaRPr lang="ja-JP" altLang="ja-JP" sz="700" i="1" kern="100" dirty="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25419" marR="25419" marT="0" marB="0" anchor="ctr"/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altLang="ja-JP" sz="700" i="0" kern="100" dirty="0" smtClean="0">
                          <a:effectLst/>
                          <a:latin typeface="Times New Roman" panose="02020603050405020304" pitchFamily="18" charset="0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RNA-spray-induced gene silencing</a:t>
                      </a:r>
                      <a:endParaRPr lang="ja-JP" altLang="ja-JP" sz="700" i="0" kern="100" dirty="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25419" marR="25419" marT="0" marB="0" anchor="ctr"/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altLang="ja-JP" sz="700" i="0" u="none" kern="100" dirty="0" smtClean="0">
                          <a:effectLst/>
                          <a:latin typeface="Times New Roman" panose="02020603050405020304" pitchFamily="18" charset="0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GATCAC</a:t>
                      </a:r>
                      <a:r>
                        <a:rPr lang="en-US" altLang="ja-JP" sz="700" i="0" u="sng" kern="100" dirty="0" smtClean="0">
                          <a:effectLst/>
                          <a:latin typeface="Times New Roman" panose="02020603050405020304" pitchFamily="18" charset="0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TAATACGACTCACTATAGGG</a:t>
                      </a:r>
                    </a:p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altLang="ja-JP" sz="700" i="0" kern="100" dirty="0" smtClean="0">
                          <a:effectLst/>
                          <a:latin typeface="Times New Roman" panose="02020603050405020304" pitchFamily="18" charset="0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CGGTCTGATGATGGATTGGAGAG</a:t>
                      </a:r>
                      <a:endParaRPr lang="ja-JP" altLang="ja-JP" sz="700" i="0" kern="100" dirty="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25419" marR="25419" marT="0" marB="0" anchor="ctr"/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altLang="ja-JP" sz="700" u="none" kern="100" dirty="0" smtClean="0">
                          <a:effectLst/>
                          <a:latin typeface="Times New Roman" panose="02020603050405020304" pitchFamily="18" charset="0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GATCAC</a:t>
                      </a:r>
                      <a:r>
                        <a:rPr lang="en-US" altLang="ja-JP" sz="700" u="sng" kern="100" dirty="0" smtClean="0">
                          <a:effectLst/>
                          <a:latin typeface="Times New Roman" panose="02020603050405020304" pitchFamily="18" charset="0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TAATACGACTCACTATAGGG</a:t>
                      </a:r>
                    </a:p>
                    <a:p>
                      <a:pPr algn="l"/>
                      <a:r>
                        <a:rPr lang="en-US" altLang="ja-JP" sz="700" kern="100" dirty="0" smtClean="0">
                          <a:effectLst/>
                          <a:latin typeface="Times New Roman" panose="02020603050405020304" pitchFamily="18" charset="0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CAGCATAGCCTCCTTCAGTATC</a:t>
                      </a:r>
                      <a:endParaRPr lang="ja-JP" sz="700" kern="100" dirty="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25419" marR="25419" marT="0" marB="0" anchor="ctr"/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altLang="ja-JP" sz="700" kern="100" smtClean="0">
                          <a:effectLst/>
                          <a:latin typeface="Times New Roman" panose="02020603050405020304" pitchFamily="18" charset="0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This study</a:t>
                      </a:r>
                      <a:endParaRPr lang="ja-JP" altLang="ja-JP" sz="700" kern="100" dirty="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25419" marR="25419" marT="0" marB="0" anchor="ctr"/>
                </a:tc>
              </a:tr>
              <a:tr h="244314"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altLang="ja-JP" sz="700" i="1" kern="100" smtClean="0">
                          <a:effectLst/>
                          <a:latin typeface="Times New Roman" panose="02020603050405020304" pitchFamily="18" charset="0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PpCHS5-1</a:t>
                      </a:r>
                      <a:endParaRPr lang="ja-JP" altLang="ja-JP" sz="700" i="1" kern="100" dirty="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25419" marR="25419" marT="0" marB="0" anchor="ctr"/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altLang="ja-JP" sz="700" i="0" kern="100" smtClean="0">
                          <a:effectLst/>
                          <a:latin typeface="Times New Roman" panose="02020603050405020304" pitchFamily="18" charset="0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RNA-spray-induced gene silencing</a:t>
                      </a:r>
                      <a:endParaRPr lang="ja-JP" altLang="ja-JP" sz="700" i="0" kern="100" dirty="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25419" marR="25419" marT="0" marB="0" anchor="ctr"/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altLang="ja-JP" sz="700" i="0" u="none" kern="100" dirty="0" smtClean="0">
                          <a:effectLst/>
                          <a:latin typeface="Times New Roman" panose="02020603050405020304" pitchFamily="18" charset="0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GATCAC</a:t>
                      </a:r>
                      <a:r>
                        <a:rPr lang="en-US" altLang="ja-JP" sz="700" i="0" u="sng" kern="100" dirty="0" smtClean="0">
                          <a:effectLst/>
                          <a:latin typeface="Times New Roman" panose="02020603050405020304" pitchFamily="18" charset="0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TAATACGACTCACTATAGGG</a:t>
                      </a:r>
                    </a:p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altLang="ja-JP" sz="700" i="0" kern="100" dirty="0" smtClean="0">
                          <a:effectLst/>
                          <a:latin typeface="Times New Roman" panose="02020603050405020304" pitchFamily="18" charset="0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TGGCAGCACTTCAATTCAGTAAGG</a:t>
                      </a:r>
                      <a:endParaRPr lang="ja-JP" altLang="ja-JP" sz="700" i="0" kern="100" dirty="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25419" marR="25419" marT="0" marB="0" anchor="ctr"/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altLang="ja-JP" sz="700" u="none" kern="100" dirty="0" smtClean="0">
                          <a:effectLst/>
                          <a:latin typeface="Times New Roman" panose="02020603050405020304" pitchFamily="18" charset="0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GATCAC</a:t>
                      </a:r>
                      <a:r>
                        <a:rPr lang="en-US" altLang="ja-JP" sz="700" u="sng" kern="100" dirty="0" smtClean="0">
                          <a:effectLst/>
                          <a:latin typeface="Times New Roman" panose="02020603050405020304" pitchFamily="18" charset="0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TAATACGACTCACTATAGGG</a:t>
                      </a:r>
                    </a:p>
                    <a:p>
                      <a:pPr algn="l"/>
                      <a:r>
                        <a:rPr lang="en-US" altLang="ja-JP" sz="700" kern="100" dirty="0" smtClean="0">
                          <a:effectLst/>
                          <a:latin typeface="Times New Roman" panose="02020603050405020304" pitchFamily="18" charset="0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CATGACCTCCAGACTCGTAAAG</a:t>
                      </a:r>
                      <a:endParaRPr lang="ja-JP" sz="700" kern="100" dirty="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25419" marR="25419" marT="0" marB="0" anchor="ctr"/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altLang="ja-JP" sz="700" kern="100" smtClean="0">
                          <a:effectLst/>
                          <a:latin typeface="Times New Roman" panose="02020603050405020304" pitchFamily="18" charset="0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This study</a:t>
                      </a:r>
                      <a:endParaRPr lang="ja-JP" altLang="ja-JP" sz="700" kern="100" dirty="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25419" marR="25419" marT="0" marB="0" anchor="ctr"/>
                </a:tc>
              </a:tr>
              <a:tr h="244314"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altLang="ja-JP" sz="700" i="1" kern="100" dirty="0" smtClean="0">
                          <a:effectLst/>
                          <a:latin typeface="Times New Roman" panose="02020603050405020304" pitchFamily="18" charset="0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PpCHS5-1</a:t>
                      </a:r>
                      <a:endParaRPr lang="ja-JP" altLang="ja-JP" sz="700" i="1" kern="100" dirty="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25419" marR="25419" marT="0" marB="0" anchor="ctr"/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altLang="ja-JP" sz="700" i="0" kern="100" dirty="0" smtClean="0">
                          <a:effectLst/>
                          <a:latin typeface="Times New Roman" panose="02020603050405020304" pitchFamily="18" charset="0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RNA-spray-induced gene silencing</a:t>
                      </a:r>
                      <a:endParaRPr lang="ja-JP" altLang="ja-JP" sz="700" i="0" kern="100" dirty="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25419" marR="25419" marT="0" marB="0" anchor="ctr"/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altLang="ja-JP" sz="700" i="0" u="none" kern="100" dirty="0" smtClean="0">
                          <a:effectLst/>
                          <a:latin typeface="Times New Roman" panose="02020603050405020304" pitchFamily="18" charset="0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GATCAC</a:t>
                      </a:r>
                      <a:r>
                        <a:rPr lang="en-US" altLang="ja-JP" sz="700" i="0" u="sng" kern="100" dirty="0" smtClean="0">
                          <a:effectLst/>
                          <a:latin typeface="Times New Roman" panose="02020603050405020304" pitchFamily="18" charset="0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TAATACGACTCACTATAGGG</a:t>
                      </a:r>
                    </a:p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altLang="ja-JP" sz="700" i="0" kern="100" dirty="0" smtClean="0">
                          <a:effectLst/>
                          <a:latin typeface="Times New Roman" panose="02020603050405020304" pitchFamily="18" charset="0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TTGAGCAAGACTCGGGTTATG</a:t>
                      </a:r>
                      <a:endParaRPr lang="ja-JP" altLang="ja-JP" sz="700" i="0" kern="100" dirty="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25419" marR="25419" marT="0" marB="0" anchor="ctr"/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altLang="ja-JP" sz="700" u="none" kern="100" dirty="0" smtClean="0">
                          <a:effectLst/>
                          <a:latin typeface="Times New Roman" panose="02020603050405020304" pitchFamily="18" charset="0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GATCAC</a:t>
                      </a:r>
                      <a:r>
                        <a:rPr lang="en-US" altLang="ja-JP" sz="700" u="sng" kern="100" dirty="0" smtClean="0">
                          <a:effectLst/>
                          <a:latin typeface="Times New Roman" panose="02020603050405020304" pitchFamily="18" charset="0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TAATACGACTCACTATAGGG</a:t>
                      </a:r>
                    </a:p>
                    <a:p>
                      <a:pPr algn="l"/>
                      <a:r>
                        <a:rPr lang="en-US" altLang="ja-JP" sz="700" kern="100" dirty="0" smtClean="0">
                          <a:effectLst/>
                          <a:latin typeface="Times New Roman" panose="02020603050405020304" pitchFamily="18" charset="0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TGGGTGCCTGATCGAGAAATAG</a:t>
                      </a:r>
                      <a:endParaRPr lang="ja-JP" sz="700" kern="100" dirty="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25419" marR="25419" marT="0" marB="0" anchor="ctr"/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altLang="ja-JP" sz="700" kern="100" dirty="0" smtClean="0">
                          <a:effectLst/>
                          <a:latin typeface="Times New Roman" panose="02020603050405020304" pitchFamily="18" charset="0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This study</a:t>
                      </a:r>
                      <a:endParaRPr lang="ja-JP" altLang="ja-JP" sz="700" kern="100" dirty="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25419" marR="25419" marT="0" marB="0" anchor="ctr"/>
                </a:tc>
              </a:tr>
              <a:tr h="244314"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altLang="ja-JP" sz="700" i="1" kern="100" dirty="0" smtClean="0">
                          <a:effectLst/>
                          <a:latin typeface="Times New Roman" panose="02020603050405020304" pitchFamily="18" charset="0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PpCHS5-2</a:t>
                      </a:r>
                      <a:endParaRPr lang="ja-JP" sz="700" i="1" kern="100" dirty="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25419" marR="25419" marT="0" marB="0" anchor="ctr"/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altLang="ja-JP" sz="700" kern="0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xpression analysis for </a:t>
                      </a:r>
                      <a:r>
                        <a:rPr lang="en-US" altLang="ja-JP" sz="700" i="1" kern="0" baseline="0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. </a:t>
                      </a:r>
                      <a:r>
                        <a:rPr lang="en-US" altLang="ja-JP" sz="700" i="1" kern="0" baseline="0" dirty="0" err="1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achyrhizi</a:t>
                      </a:r>
                      <a:endParaRPr lang="ja-JP" altLang="ja-JP" sz="700" i="0" kern="100" dirty="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25419" marR="25419" marT="0" marB="0" anchor="ctr"/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altLang="ja-JP" sz="700" kern="100" dirty="0" smtClean="0">
                          <a:effectLst/>
                          <a:latin typeface="Times New Roman" panose="02020603050405020304" pitchFamily="18" charset="0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AGTCTTGAAGAGGCGGATAATG</a:t>
                      </a:r>
                      <a:endParaRPr lang="ja-JP" altLang="ja-JP" sz="700" i="0" kern="100" dirty="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25419" marR="25419" marT="0" marB="0" anchor="ctr"/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altLang="ja-JP" sz="700" kern="100" dirty="0" smtClean="0">
                          <a:effectLst/>
                          <a:latin typeface="Times New Roman" panose="02020603050405020304" pitchFamily="18" charset="0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CATATCTCATCACTCCCATGGAC</a:t>
                      </a:r>
                      <a:endParaRPr lang="ja-JP" sz="700" kern="100" dirty="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25419" marR="25419" marT="0" marB="0" anchor="ctr"/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altLang="ja-JP" sz="700" kern="100" dirty="0" smtClean="0">
                          <a:effectLst/>
                          <a:latin typeface="Times New Roman" panose="02020603050405020304" pitchFamily="18" charset="0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This study</a:t>
                      </a:r>
                      <a:endParaRPr lang="ja-JP" altLang="ja-JP" sz="700" kern="100" dirty="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25419" marR="25419" marT="0" marB="0" anchor="ctr"/>
                </a:tc>
              </a:tr>
              <a:tr h="244314"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700" i="1" kern="100" dirty="0" smtClean="0">
                          <a:effectLst/>
                          <a:latin typeface="Times New Roman" panose="02020603050405020304" pitchFamily="18" charset="0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PpEF1</a:t>
                      </a:r>
                      <a:r>
                        <a:rPr lang="en-US" altLang="ja-JP" sz="700" i="1" kern="100" dirty="0" smtClean="0">
                          <a:effectLst/>
                          <a:latin typeface="Symbol" panose="05050102010706020507" pitchFamily="18" charset="2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a</a:t>
                      </a:r>
                      <a:endParaRPr lang="ja-JP" altLang="ja-JP" sz="700" i="1" kern="100" dirty="0" smtClean="0">
                        <a:effectLst/>
                        <a:latin typeface="Symbol" panose="05050102010706020507" pitchFamily="18" charset="2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25419" marR="25419" marT="0" marB="0" anchor="ctr"/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altLang="ja-JP" sz="700" kern="0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xpression analysis for </a:t>
                      </a:r>
                      <a:r>
                        <a:rPr lang="en-US" altLang="ja-JP" sz="700" i="1" kern="0" baseline="0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. </a:t>
                      </a:r>
                      <a:r>
                        <a:rPr lang="en-US" altLang="ja-JP" sz="700" i="1" kern="0" baseline="0" dirty="0" err="1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achyrhizi</a:t>
                      </a:r>
                      <a:endParaRPr lang="ja-JP" altLang="ja-JP" sz="700" i="0" kern="100" dirty="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25419" marR="25419" marT="0" marB="0" anchor="ctr"/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altLang="ja-JP" sz="700" kern="100" dirty="0" smtClean="0">
                          <a:effectLst/>
                          <a:latin typeface="Times New Roman" panose="02020603050405020304" pitchFamily="18" charset="0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ATACGCTCCTGTCCTTGATTGCCA</a:t>
                      </a:r>
                      <a:endParaRPr lang="ja-JP" altLang="ja-JP" sz="700" i="0" kern="100" dirty="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25419" marR="25419" marT="0" marB="0" anchor="ctr"/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altLang="ja-JP" sz="700" kern="100" dirty="0" smtClean="0">
                          <a:effectLst/>
                          <a:latin typeface="Times New Roman" panose="02020603050405020304" pitchFamily="18" charset="0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AACAGTTTGCCTCATGTCACGCAC</a:t>
                      </a:r>
                      <a:endParaRPr lang="ja-JP" sz="700" kern="100" dirty="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25419" marR="25419" marT="0" marB="0" anchor="ctr"/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altLang="ja-JP" sz="700" kern="100" dirty="0" smtClean="0">
                          <a:effectLst/>
                          <a:latin typeface="Times New Roman" panose="02020603050405020304" pitchFamily="18" charset="0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Ishiga et al.,</a:t>
                      </a:r>
                      <a:r>
                        <a:rPr lang="en-US" altLang="ja-JP" sz="700" kern="100" baseline="0" dirty="0" smtClean="0">
                          <a:effectLst/>
                          <a:latin typeface="Times New Roman" panose="02020603050405020304" pitchFamily="18" charset="0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 2013</a:t>
                      </a:r>
                      <a:endParaRPr lang="en-US" altLang="ja-JP" sz="700" kern="100" dirty="0" smtClean="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25419" marR="25419" marT="0" marB="0" anchor="ctr"/>
                </a:tc>
              </a:tr>
              <a:tr h="244314"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altLang="ja-JP" sz="700" i="1" kern="0" dirty="0" smtClean="0"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PpUBQ5</a:t>
                      </a:r>
                      <a:endParaRPr lang="ja-JP" sz="700" i="1" kern="100" dirty="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25419" marR="25419" marT="0" marB="0" anchor="ctr"/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altLang="ja-JP" sz="700" kern="0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xpression analysis for </a:t>
                      </a:r>
                      <a:r>
                        <a:rPr lang="en-US" altLang="ja-JP" sz="700" i="1" kern="0" baseline="0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. </a:t>
                      </a:r>
                      <a:r>
                        <a:rPr lang="en-US" altLang="ja-JP" sz="700" i="1" kern="0" baseline="0" dirty="0" err="1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achyrhizi</a:t>
                      </a:r>
                      <a:endParaRPr lang="ja-JP" altLang="ja-JP" sz="700" i="0" kern="100" dirty="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25419" marR="25419" marT="0" marB="0" anchor="ctr"/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altLang="ja-JP" sz="700" kern="100" dirty="0" smtClean="0">
                          <a:effectLst/>
                          <a:latin typeface="Times New Roman" panose="02020603050405020304" pitchFamily="18" charset="0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AGAGGGAATTCCTCCAGACCAACA</a:t>
                      </a:r>
                      <a:endParaRPr lang="ja-JP" altLang="ja-JP" sz="700" i="0" kern="100" dirty="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25419" marR="25419" marT="0" marB="0" anchor="ctr"/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altLang="ja-JP" sz="700" kern="100" dirty="0" smtClean="0">
                          <a:effectLst/>
                          <a:latin typeface="Times New Roman" panose="02020603050405020304" pitchFamily="18" charset="0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ATTTGCATTCCACCACGAAGTCGG</a:t>
                      </a:r>
                      <a:endParaRPr lang="ja-JP" sz="700" kern="100" dirty="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25419" marR="25419" marT="0" marB="0" anchor="ctr"/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altLang="ja-JP" sz="700" kern="100" dirty="0" smtClean="0">
                          <a:effectLst/>
                          <a:latin typeface="Times New Roman" panose="02020603050405020304" pitchFamily="18" charset="0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Ishiga et al.,</a:t>
                      </a:r>
                      <a:r>
                        <a:rPr lang="en-US" altLang="ja-JP" sz="700" kern="100" baseline="0" dirty="0" smtClean="0">
                          <a:effectLst/>
                          <a:latin typeface="Times New Roman" panose="02020603050405020304" pitchFamily="18" charset="0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 2013</a:t>
                      </a:r>
                      <a:endParaRPr lang="en-US" altLang="ja-JP" sz="700" kern="100" dirty="0" smtClean="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25419" marR="25419" marT="0" marB="0" anchor="ctr"/>
                </a:tc>
              </a:tr>
              <a:tr h="244314"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altLang="ja-JP" sz="700" i="1" kern="0" dirty="0" smtClean="0"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GFP</a:t>
                      </a:r>
                      <a:endParaRPr lang="ja-JP" sz="700" i="1" kern="100" dirty="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25419" marR="25419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altLang="ja-JP" sz="700" i="0" kern="100" dirty="0" smtClean="0">
                          <a:effectLst/>
                          <a:latin typeface="Times New Roman" panose="02020603050405020304" pitchFamily="18" charset="0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RNA-spray-induced gene silencing</a:t>
                      </a:r>
                      <a:endParaRPr lang="ja-JP" altLang="ja-JP" sz="700" i="0" kern="100" dirty="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25419" marR="25419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700" i="0" u="none" kern="100" dirty="0" smtClean="0">
                          <a:effectLst/>
                          <a:latin typeface="Times New Roman" panose="02020603050405020304" pitchFamily="18" charset="0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GATCAC</a:t>
                      </a:r>
                      <a:r>
                        <a:rPr lang="en-US" altLang="ja-JP" sz="700" i="0" u="sng" kern="100" dirty="0" smtClean="0">
                          <a:effectLst/>
                          <a:latin typeface="Times New Roman" panose="02020603050405020304" pitchFamily="18" charset="0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TAATACGACTCACTATAGGG</a:t>
                      </a:r>
                    </a:p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altLang="ja-JP" sz="700" kern="100" dirty="0" smtClean="0">
                          <a:effectLst/>
                          <a:latin typeface="Times New Roman" panose="02020603050405020304" pitchFamily="18" charset="0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GTGAGCAAGGGCGAG</a:t>
                      </a:r>
                      <a:endParaRPr lang="ja-JP" altLang="ja-JP" sz="700" i="0" kern="100" dirty="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25419" marR="25419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700" i="0" u="none" kern="100" dirty="0" smtClean="0">
                          <a:effectLst/>
                          <a:latin typeface="Times New Roman" panose="02020603050405020304" pitchFamily="18" charset="0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GATCAC</a:t>
                      </a:r>
                      <a:r>
                        <a:rPr lang="en-US" altLang="ja-JP" sz="700" i="0" u="sng" kern="100" dirty="0" smtClean="0">
                          <a:effectLst/>
                          <a:latin typeface="Times New Roman" panose="02020603050405020304" pitchFamily="18" charset="0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TAATACGACTCACTATAGGG</a:t>
                      </a:r>
                    </a:p>
                    <a:p>
                      <a:pPr algn="l"/>
                      <a:r>
                        <a:rPr lang="en-US" altLang="ja-JP" sz="700" kern="100" dirty="0" smtClean="0">
                          <a:effectLst/>
                          <a:latin typeface="Times New Roman" panose="02020603050405020304" pitchFamily="18" charset="0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GTTGTACAGCTCGTCCAT</a:t>
                      </a:r>
                      <a:endParaRPr lang="ja-JP" sz="700" kern="100" dirty="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25419" marR="25419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altLang="ja-JP" sz="700" kern="100" dirty="0" smtClean="0">
                          <a:effectLst/>
                          <a:latin typeface="Times New Roman" panose="02020603050405020304" pitchFamily="18" charset="0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Koch et al.,</a:t>
                      </a:r>
                      <a:r>
                        <a:rPr lang="en-US" altLang="ja-JP" sz="700" kern="100" baseline="0" dirty="0" smtClean="0">
                          <a:effectLst/>
                          <a:latin typeface="Times New Roman" panose="02020603050405020304" pitchFamily="18" charset="0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 2016</a:t>
                      </a:r>
                      <a:endParaRPr lang="en-US" altLang="ja-JP" sz="700" kern="100" dirty="0" smtClean="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25419" marR="25419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189783981"/>
                  </a:ext>
                </a:extLst>
              </a:tr>
              <a:tr h="244314">
                <a:tc gridSpan="5"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000" i="0" kern="0" baseline="0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Underline indicates T7 promoter sequence.</a:t>
                      </a:r>
                    </a:p>
                  </a:txBody>
                  <a:tcPr marL="25419" marR="25419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ja-JP" altLang="ja-JP" sz="1000" kern="100" dirty="0" smtClean="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25419" marR="25419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ja-JP" altLang="ja-JP" sz="1000" i="0" kern="100" dirty="0" smtClean="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25419" marR="25419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pPr algn="l"/>
                      <a:endParaRPr lang="ja-JP" sz="1000" kern="100" dirty="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25419" marR="25419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endParaRPr lang="ja-JP" altLang="ja-JP" sz="1000" kern="100" dirty="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25419" marR="25419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316785762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501</TotalTime>
  <Words>391</Words>
  <Application>Microsoft Office PowerPoint</Application>
  <PresentationFormat>画面に合わせる (4:3)</PresentationFormat>
  <Paragraphs>171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8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10" baseType="lpstr">
      <vt:lpstr>游ゴシック</vt:lpstr>
      <vt:lpstr>游ゴシック Light</vt:lpstr>
      <vt:lpstr>游明朝</vt:lpstr>
      <vt:lpstr>Arial</vt:lpstr>
      <vt:lpstr>Calibri</vt:lpstr>
      <vt:lpstr>Calibri Light</vt:lpstr>
      <vt:lpstr>Symbol</vt:lpstr>
      <vt:lpstr>Times New Roman</vt:lpstr>
      <vt:lpstr>Office テーマ</vt:lpstr>
      <vt:lpstr>PowerPoint プレゼンテーション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齊藤　悠香</dc:creator>
  <cp:lastModifiedBy>石賀康博</cp:lastModifiedBy>
  <cp:revision>143</cp:revision>
  <dcterms:created xsi:type="dcterms:W3CDTF">2021-04-14T04:40:19Z</dcterms:created>
  <dcterms:modified xsi:type="dcterms:W3CDTF">2021-06-13T23:45:00Z</dcterms:modified>
</cp:coreProperties>
</file>